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366" autoAdjust="0"/>
    <p:restoredTop sz="93020" autoAdjust="0"/>
  </p:normalViewPr>
  <p:slideViewPr>
    <p:cSldViewPr snapToGrid="0">
      <p:cViewPr varScale="1">
        <p:scale>
          <a:sx n="113" d="100"/>
          <a:sy n="113" d="100"/>
        </p:scale>
        <p:origin x="6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AAF29-EA6D-4A7F-8596-C07611F931B6}" type="datetimeFigureOut">
              <a:rPr kumimoji="1" lang="ja-JP" altLang="en-US" smtClean="0"/>
              <a:t>2024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F71F1-254E-44D6-A983-C2ABE6EED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8987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AAF29-EA6D-4A7F-8596-C07611F931B6}" type="datetimeFigureOut">
              <a:rPr kumimoji="1" lang="ja-JP" altLang="en-US" smtClean="0"/>
              <a:t>2024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F71F1-254E-44D6-A983-C2ABE6EED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6053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AAF29-EA6D-4A7F-8596-C07611F931B6}" type="datetimeFigureOut">
              <a:rPr kumimoji="1" lang="ja-JP" altLang="en-US" smtClean="0"/>
              <a:t>2024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F71F1-254E-44D6-A983-C2ABE6EED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2272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AAF29-EA6D-4A7F-8596-C07611F931B6}" type="datetimeFigureOut">
              <a:rPr kumimoji="1" lang="ja-JP" altLang="en-US" smtClean="0"/>
              <a:t>2024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F71F1-254E-44D6-A983-C2ABE6EED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4818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AAF29-EA6D-4A7F-8596-C07611F931B6}" type="datetimeFigureOut">
              <a:rPr kumimoji="1" lang="ja-JP" altLang="en-US" smtClean="0"/>
              <a:t>2024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F71F1-254E-44D6-A983-C2ABE6EED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0708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AAF29-EA6D-4A7F-8596-C07611F931B6}" type="datetimeFigureOut">
              <a:rPr kumimoji="1" lang="ja-JP" altLang="en-US" smtClean="0"/>
              <a:t>2024/6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F71F1-254E-44D6-A983-C2ABE6EED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071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AAF29-EA6D-4A7F-8596-C07611F931B6}" type="datetimeFigureOut">
              <a:rPr kumimoji="1" lang="ja-JP" altLang="en-US" smtClean="0"/>
              <a:t>2024/6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F71F1-254E-44D6-A983-C2ABE6EED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31310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AAF29-EA6D-4A7F-8596-C07611F931B6}" type="datetimeFigureOut">
              <a:rPr kumimoji="1" lang="ja-JP" altLang="en-US" smtClean="0"/>
              <a:t>2024/6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F71F1-254E-44D6-A983-C2ABE6EED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5881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AAF29-EA6D-4A7F-8596-C07611F931B6}" type="datetimeFigureOut">
              <a:rPr kumimoji="1" lang="ja-JP" altLang="en-US" smtClean="0"/>
              <a:t>2024/6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F71F1-254E-44D6-A983-C2ABE6EED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5914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AAF29-EA6D-4A7F-8596-C07611F931B6}" type="datetimeFigureOut">
              <a:rPr kumimoji="1" lang="ja-JP" altLang="en-US" smtClean="0"/>
              <a:t>2024/6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F71F1-254E-44D6-A983-C2ABE6EED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6414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FAAF29-EA6D-4A7F-8596-C07611F931B6}" type="datetimeFigureOut">
              <a:rPr kumimoji="1" lang="ja-JP" altLang="en-US" smtClean="0"/>
              <a:t>2024/6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1F71F1-254E-44D6-A983-C2ABE6EED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7378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FAAF29-EA6D-4A7F-8596-C07611F931B6}" type="datetimeFigureOut">
              <a:rPr kumimoji="1" lang="ja-JP" altLang="en-US" smtClean="0"/>
              <a:t>2024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1F71F1-254E-44D6-A983-C2ABE6EED9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364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9D4114E-C783-C67E-4639-59DE29B7EF88}"/>
              </a:ext>
            </a:extLst>
          </p:cNvPr>
          <p:cNvSpPr txBox="1"/>
          <p:nvPr/>
        </p:nvSpPr>
        <p:spPr>
          <a:xfrm>
            <a:off x="421249" y="302951"/>
            <a:ext cx="297816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Panoramic radiographs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 descr="白黒の写真&#10;&#10;低い精度で自動的に生成された説明">
            <a:extLst>
              <a:ext uri="{FF2B5EF4-FFF2-40B4-BE49-F238E27FC236}">
                <a16:creationId xmlns:a16="http://schemas.microsoft.com/office/drawing/2014/main" id="{2E13E29D-6863-1D2F-D5EA-3D999F411E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494072"/>
            <a:ext cx="4625339" cy="2082613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3B33F63D-0F52-3296-4C05-047BEC056EC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1" y="3710294"/>
            <a:ext cx="4625335" cy="2082612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8B9CB24-7A73-2A04-2BCD-DE92AA734FE9}"/>
              </a:ext>
            </a:extLst>
          </p:cNvPr>
          <p:cNvSpPr txBox="1"/>
          <p:nvPr/>
        </p:nvSpPr>
        <p:spPr>
          <a:xfrm>
            <a:off x="6470890" y="1092981"/>
            <a:ext cx="38755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ernumerary teeth 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図 13" descr="レントゲン, 爬虫類, 抽象 が含まれている画像&#10;&#10;自動的に生成された説明">
            <a:extLst>
              <a:ext uri="{FF2B5EF4-FFF2-40B4-BE49-F238E27FC236}">
                <a16:creationId xmlns:a16="http://schemas.microsoft.com/office/drawing/2014/main" id="{1C91A768-4EC3-D9BD-7FDC-33213FAE397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3960" y="1489243"/>
            <a:ext cx="4076469" cy="2087442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3D8EB17-417C-8E60-B899-4A78829487E8}"/>
              </a:ext>
            </a:extLst>
          </p:cNvPr>
          <p:cNvSpPr txBox="1"/>
          <p:nvPr/>
        </p:nvSpPr>
        <p:spPr>
          <a:xfrm>
            <a:off x="2100416" y="1092981"/>
            <a:ext cx="35835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o dental anomalies 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図 17" descr="白黒の写真に写ってる男性の顔&#10;&#10;低い精度で自動的に生成された説明">
            <a:extLst>
              <a:ext uri="{FF2B5EF4-FFF2-40B4-BE49-F238E27FC236}">
                <a16:creationId xmlns:a16="http://schemas.microsoft.com/office/drawing/2014/main" id="{E073D101-F489-A631-3778-A22A29CBC9F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3960" y="3710294"/>
            <a:ext cx="4075576" cy="2086985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0151FD8-9BD8-E21A-8F15-BA7B3210E0B6}"/>
              </a:ext>
            </a:extLst>
          </p:cNvPr>
          <p:cNvSpPr txBox="1"/>
          <p:nvPr/>
        </p:nvSpPr>
        <p:spPr>
          <a:xfrm rot="16200000">
            <a:off x="717336" y="4566934"/>
            <a:ext cx="15540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LAHE 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50292F0-DB29-7BAF-AB3D-B3D1CD419F74}"/>
              </a:ext>
            </a:extLst>
          </p:cNvPr>
          <p:cNvSpPr txBox="1"/>
          <p:nvPr/>
        </p:nvSpPr>
        <p:spPr>
          <a:xfrm rot="16200000">
            <a:off x="717337" y="2348298"/>
            <a:ext cx="15540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Original 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25245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人のレントゲン写真&#10;&#10;低い精度で自動的に生成された説明">
            <a:extLst>
              <a:ext uri="{FF2B5EF4-FFF2-40B4-BE49-F238E27FC236}">
                <a16:creationId xmlns:a16="http://schemas.microsoft.com/office/drawing/2014/main" id="{69EBEBFF-B1A4-4FA7-B37F-6ABE5CA32E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5205" y="1105677"/>
            <a:ext cx="2107684" cy="2532290"/>
          </a:xfrm>
          <a:prstGeom prst="rect">
            <a:avLst/>
          </a:prstGeom>
        </p:spPr>
      </p:pic>
      <p:pic>
        <p:nvPicPr>
          <p:cNvPr id="7" name="図 6" descr="人のレントゲン写真&#10;&#10;低い精度で自動的に生成された説明">
            <a:extLst>
              <a:ext uri="{FF2B5EF4-FFF2-40B4-BE49-F238E27FC236}">
                <a16:creationId xmlns:a16="http://schemas.microsoft.com/office/drawing/2014/main" id="{B400F5C4-D24A-40A3-2CF4-A81B460CF6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5205" y="3818602"/>
            <a:ext cx="2107683" cy="2532289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DF16145-1390-331C-354B-4D5196D68FFA}"/>
              </a:ext>
            </a:extLst>
          </p:cNvPr>
          <p:cNvSpPr txBox="1"/>
          <p:nvPr/>
        </p:nvSpPr>
        <p:spPr>
          <a:xfrm>
            <a:off x="3706315" y="736345"/>
            <a:ext cx="18254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8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Male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 descr="人のレントゲン写真&#10;&#10;低い精度で自動的に生成された説明">
            <a:extLst>
              <a:ext uri="{FF2B5EF4-FFF2-40B4-BE49-F238E27FC236}">
                <a16:creationId xmlns:a16="http://schemas.microsoft.com/office/drawing/2014/main" id="{A14B3BF0-F599-387C-C8B1-5F187AEAE2A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9806" y="1105677"/>
            <a:ext cx="2107684" cy="2532290"/>
          </a:xfrm>
          <a:prstGeom prst="rect">
            <a:avLst/>
          </a:prstGeom>
        </p:spPr>
      </p:pic>
      <p:pic>
        <p:nvPicPr>
          <p:cNvPr id="17" name="図 16" descr="レントゲン, 屋内, カップ, 座る が含まれている画像&#10;&#10;自動的に生成された説明">
            <a:extLst>
              <a:ext uri="{FF2B5EF4-FFF2-40B4-BE49-F238E27FC236}">
                <a16:creationId xmlns:a16="http://schemas.microsoft.com/office/drawing/2014/main" id="{022A98E6-141F-F5D0-E3E0-90214207D6C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9806" y="3813667"/>
            <a:ext cx="2107684" cy="2532290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E9A193B-6F66-32C9-918E-500C8D655C7E}"/>
              </a:ext>
            </a:extLst>
          </p:cNvPr>
          <p:cNvSpPr txBox="1"/>
          <p:nvPr/>
        </p:nvSpPr>
        <p:spPr>
          <a:xfrm>
            <a:off x="6010917" y="736345"/>
            <a:ext cx="18254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8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Female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72D1612-510C-F80E-2B55-6A2B426F9AB8}"/>
              </a:ext>
            </a:extLst>
          </p:cNvPr>
          <p:cNvSpPr txBox="1"/>
          <p:nvPr/>
        </p:nvSpPr>
        <p:spPr>
          <a:xfrm>
            <a:off x="421249" y="302951"/>
            <a:ext cx="42442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Lateral cephalometric radiographs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08C86D7-B6AF-D4EF-7206-1E32A9AAD5EC}"/>
              </a:ext>
            </a:extLst>
          </p:cNvPr>
          <p:cNvSpPr txBox="1"/>
          <p:nvPr/>
        </p:nvSpPr>
        <p:spPr>
          <a:xfrm rot="16200000">
            <a:off x="2028177" y="4898226"/>
            <a:ext cx="23572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LAHE 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4DD6C23-2E15-2166-8395-A4ADF7CB8783}"/>
              </a:ext>
            </a:extLst>
          </p:cNvPr>
          <p:cNvSpPr txBox="1"/>
          <p:nvPr/>
        </p:nvSpPr>
        <p:spPr>
          <a:xfrm rot="16200000">
            <a:off x="2028177" y="2265745"/>
            <a:ext cx="23572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Original 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825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2d571ce-5d5e-4577-851b-36fe2b87e29c" xsi:nil="true"/>
    <lcf76f155ced4ddcb4097134ff3c332f xmlns="7805362c-7fb7-47ff-9049-83b2c46e6485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8" ma:contentTypeDescription="Create a new document." ma:contentTypeScope="" ma:versionID="5d2d8db6fea1d1812808fd55738c9f69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1fde52f5973b0c0dfb47cad0919e8cf1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Location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3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62F8421C-F60C-4D80-88CB-85B8E1007809}">
  <ds:schemaRefs>
    <ds:schemaRef ds:uri="http://schemas.microsoft.com/office/2006/metadata/properties"/>
    <ds:schemaRef ds:uri="http://schemas.microsoft.com/office/infopath/2007/PartnerControls"/>
    <ds:schemaRef ds:uri="22d571ce-5d5e-4577-851b-36fe2b87e29c"/>
    <ds:schemaRef ds:uri="7805362c-7fb7-47ff-9049-83b2c46e6485"/>
  </ds:schemaRefs>
</ds:datastoreItem>
</file>

<file path=customXml/itemProps2.xml><?xml version="1.0" encoding="utf-8"?>
<ds:datastoreItem xmlns:ds="http://schemas.openxmlformats.org/officeDocument/2006/customXml" ds:itemID="{E5862850-1EA7-4F9C-8C85-87B3738CC3E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7EBA435-540A-47D6-B484-30B3BCA41F3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03</TotalTime>
  <Words>16</Words>
  <Application>Microsoft Macintosh PowerPoint</Application>
  <PresentationFormat>ワイド画面</PresentationFormat>
  <Paragraphs>1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岡崎　昌太</dc:creator>
  <cp:lastModifiedBy>mine@jsd.med.kyushu-u.ac.jp</cp:lastModifiedBy>
  <cp:revision>53</cp:revision>
  <dcterms:created xsi:type="dcterms:W3CDTF">2023-08-05T00:20:22Z</dcterms:created>
  <dcterms:modified xsi:type="dcterms:W3CDTF">2024-06-25T01:39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D935350FB4524AA9B0551AC744F54C</vt:lpwstr>
  </property>
</Properties>
</file>